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handoutMasterIdLst>
    <p:handoutMasterId r:id="rId5"/>
  </p:handoutMasterIdLst>
  <p:sldIdLst>
    <p:sldId id="377" r:id="rId2"/>
    <p:sldId id="378" r:id="rId3"/>
    <p:sldId id="376" r:id="rId4"/>
  </p:sldIdLst>
  <p:sldSz cx="21601113" cy="233997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24" d="100"/>
          <a:sy n="24" d="100"/>
        </p:scale>
        <p:origin x="2270" y="11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2" d="100"/>
          <a:sy n="62" d="100"/>
        </p:scale>
        <p:origin x="2155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4A0EC4C4-EE62-5C23-E1AF-B937A25699D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8A9FC0C-7A73-B0B7-7CAD-1D4165E9543C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1A968C-64D7-4032-A870-74695AD83E0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AA4AEDF-1EB2-A46F-82F3-7A589CDCA6F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4A1CCC7-6F56-A8F8-3A0B-D033BBEAF8D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9722F8-008F-4A25-B405-32BCD72D31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1296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20084" y="3829544"/>
            <a:ext cx="18360946" cy="8146580"/>
          </a:xfrm>
        </p:spPr>
        <p:txBody>
          <a:bodyPr anchor="b"/>
          <a:lstStyle>
            <a:lvl1pPr algn="ctr">
              <a:defRPr sz="141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0139" y="12290287"/>
            <a:ext cx="16200835" cy="5649521"/>
          </a:xfrm>
        </p:spPr>
        <p:txBody>
          <a:bodyPr/>
          <a:lstStyle>
            <a:lvl1pPr marL="0" indent="0" algn="ctr">
              <a:buNone/>
              <a:defRPr sz="5670"/>
            </a:lvl1pPr>
            <a:lvl2pPr marL="1080044" indent="0" algn="ctr">
              <a:buNone/>
              <a:defRPr sz="4725"/>
            </a:lvl2pPr>
            <a:lvl3pPr marL="2160087" indent="0" algn="ctr">
              <a:buNone/>
              <a:defRPr sz="4252"/>
            </a:lvl3pPr>
            <a:lvl4pPr marL="3240131" indent="0" algn="ctr">
              <a:buNone/>
              <a:defRPr sz="3780"/>
            </a:lvl4pPr>
            <a:lvl5pPr marL="4320174" indent="0" algn="ctr">
              <a:buNone/>
              <a:defRPr sz="3780"/>
            </a:lvl5pPr>
            <a:lvl6pPr marL="5400218" indent="0" algn="ctr">
              <a:buNone/>
              <a:defRPr sz="3780"/>
            </a:lvl6pPr>
            <a:lvl7pPr marL="6480261" indent="0" algn="ctr">
              <a:buNone/>
              <a:defRPr sz="3780"/>
            </a:lvl7pPr>
            <a:lvl8pPr marL="7560305" indent="0" algn="ctr">
              <a:buNone/>
              <a:defRPr sz="3780"/>
            </a:lvl8pPr>
            <a:lvl9pPr marL="8640348" indent="0" algn="ctr">
              <a:buNone/>
              <a:defRPr sz="37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230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6299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8298" y="1245820"/>
            <a:ext cx="4657740" cy="1983020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5078" y="1245820"/>
            <a:ext cx="13703206" cy="1983020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900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490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827" y="5833695"/>
            <a:ext cx="18630960" cy="9733644"/>
          </a:xfrm>
        </p:spPr>
        <p:txBody>
          <a:bodyPr anchor="b"/>
          <a:lstStyle>
            <a:lvl1pPr>
              <a:defRPr sz="141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827" y="15659423"/>
            <a:ext cx="18630960" cy="5118694"/>
          </a:xfrm>
        </p:spPr>
        <p:txBody>
          <a:bodyPr/>
          <a:lstStyle>
            <a:lvl1pPr marL="0" indent="0">
              <a:buNone/>
              <a:defRPr sz="5670">
                <a:solidFill>
                  <a:schemeClr val="tx1"/>
                </a:solidFill>
              </a:defRPr>
            </a:lvl1pPr>
            <a:lvl2pPr marL="1080044" indent="0">
              <a:buNone/>
              <a:defRPr sz="4725">
                <a:solidFill>
                  <a:schemeClr val="tx1">
                    <a:tint val="75000"/>
                  </a:schemeClr>
                </a:solidFill>
              </a:defRPr>
            </a:lvl2pPr>
            <a:lvl3pPr marL="2160087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3pPr>
            <a:lvl4pPr marL="324013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4pPr>
            <a:lvl5pPr marL="4320174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5pPr>
            <a:lvl6pPr marL="5400218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6pPr>
            <a:lvl7pPr marL="648026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7pPr>
            <a:lvl8pPr marL="7560305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8pPr>
            <a:lvl9pPr marL="8640348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0048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5077" y="6229100"/>
            <a:ext cx="9180473" cy="148469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5563" y="6229100"/>
            <a:ext cx="9180473" cy="148469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7281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245825"/>
            <a:ext cx="18630960" cy="452287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892" y="5736191"/>
            <a:ext cx="9138282" cy="2811218"/>
          </a:xfrm>
        </p:spPr>
        <p:txBody>
          <a:bodyPr anchor="b"/>
          <a:lstStyle>
            <a:lvl1pPr marL="0" indent="0">
              <a:buNone/>
              <a:defRPr sz="5670" b="1"/>
            </a:lvl1pPr>
            <a:lvl2pPr marL="1080044" indent="0">
              <a:buNone/>
              <a:defRPr sz="4725" b="1"/>
            </a:lvl2pPr>
            <a:lvl3pPr marL="2160087" indent="0">
              <a:buNone/>
              <a:defRPr sz="4252" b="1"/>
            </a:lvl3pPr>
            <a:lvl4pPr marL="3240131" indent="0">
              <a:buNone/>
              <a:defRPr sz="3780" b="1"/>
            </a:lvl4pPr>
            <a:lvl5pPr marL="4320174" indent="0">
              <a:buNone/>
              <a:defRPr sz="3780" b="1"/>
            </a:lvl5pPr>
            <a:lvl6pPr marL="5400218" indent="0">
              <a:buNone/>
              <a:defRPr sz="3780" b="1"/>
            </a:lvl6pPr>
            <a:lvl7pPr marL="6480261" indent="0">
              <a:buNone/>
              <a:defRPr sz="3780" b="1"/>
            </a:lvl7pPr>
            <a:lvl8pPr marL="7560305" indent="0">
              <a:buNone/>
              <a:defRPr sz="3780" b="1"/>
            </a:lvl8pPr>
            <a:lvl9pPr marL="8640348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892" y="8547409"/>
            <a:ext cx="9138282" cy="125719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5564" y="5736191"/>
            <a:ext cx="9183287" cy="2811218"/>
          </a:xfrm>
        </p:spPr>
        <p:txBody>
          <a:bodyPr anchor="b"/>
          <a:lstStyle>
            <a:lvl1pPr marL="0" indent="0">
              <a:buNone/>
              <a:defRPr sz="5670" b="1"/>
            </a:lvl1pPr>
            <a:lvl2pPr marL="1080044" indent="0">
              <a:buNone/>
              <a:defRPr sz="4725" b="1"/>
            </a:lvl2pPr>
            <a:lvl3pPr marL="2160087" indent="0">
              <a:buNone/>
              <a:defRPr sz="4252" b="1"/>
            </a:lvl3pPr>
            <a:lvl4pPr marL="3240131" indent="0">
              <a:buNone/>
              <a:defRPr sz="3780" b="1"/>
            </a:lvl4pPr>
            <a:lvl5pPr marL="4320174" indent="0">
              <a:buNone/>
              <a:defRPr sz="3780" b="1"/>
            </a:lvl5pPr>
            <a:lvl6pPr marL="5400218" indent="0">
              <a:buNone/>
              <a:defRPr sz="3780" b="1"/>
            </a:lvl6pPr>
            <a:lvl7pPr marL="6480261" indent="0">
              <a:buNone/>
              <a:defRPr sz="3780" b="1"/>
            </a:lvl7pPr>
            <a:lvl8pPr marL="7560305" indent="0">
              <a:buNone/>
              <a:defRPr sz="3780" b="1"/>
            </a:lvl8pPr>
            <a:lvl9pPr marL="8640348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5564" y="8547409"/>
            <a:ext cx="9183287" cy="125719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319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077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1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559983"/>
            <a:ext cx="6966921" cy="5459942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3287" y="3369136"/>
            <a:ext cx="10935563" cy="16628989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70"/>
            </a:lvl3pPr>
            <a:lvl4pPr>
              <a:defRPr sz="4725"/>
            </a:lvl4pPr>
            <a:lvl5pPr>
              <a:defRPr sz="4725"/>
            </a:lvl5pPr>
            <a:lvl6pPr>
              <a:defRPr sz="4725"/>
            </a:lvl6pPr>
            <a:lvl7pPr>
              <a:defRPr sz="4725"/>
            </a:lvl7pPr>
            <a:lvl8pPr>
              <a:defRPr sz="4725"/>
            </a:lvl8pPr>
            <a:lvl9pPr>
              <a:defRPr sz="47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0" y="7019925"/>
            <a:ext cx="6966921" cy="13005279"/>
          </a:xfrm>
        </p:spPr>
        <p:txBody>
          <a:bodyPr/>
          <a:lstStyle>
            <a:lvl1pPr marL="0" indent="0">
              <a:buNone/>
              <a:defRPr sz="3780"/>
            </a:lvl1pPr>
            <a:lvl2pPr marL="1080044" indent="0">
              <a:buNone/>
              <a:defRPr sz="3307"/>
            </a:lvl2pPr>
            <a:lvl3pPr marL="2160087" indent="0">
              <a:buNone/>
              <a:defRPr sz="2835"/>
            </a:lvl3pPr>
            <a:lvl4pPr marL="3240131" indent="0">
              <a:buNone/>
              <a:defRPr sz="2362"/>
            </a:lvl4pPr>
            <a:lvl5pPr marL="4320174" indent="0">
              <a:buNone/>
              <a:defRPr sz="2362"/>
            </a:lvl5pPr>
            <a:lvl6pPr marL="5400218" indent="0">
              <a:buNone/>
              <a:defRPr sz="2362"/>
            </a:lvl6pPr>
            <a:lvl7pPr marL="6480261" indent="0">
              <a:buNone/>
              <a:defRPr sz="2362"/>
            </a:lvl7pPr>
            <a:lvl8pPr marL="7560305" indent="0">
              <a:buNone/>
              <a:defRPr sz="2362"/>
            </a:lvl8pPr>
            <a:lvl9pPr marL="8640348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550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559983"/>
            <a:ext cx="6966921" cy="5459942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3287" y="3369136"/>
            <a:ext cx="10935563" cy="16628989"/>
          </a:xfrm>
        </p:spPr>
        <p:txBody>
          <a:bodyPr anchor="t"/>
          <a:lstStyle>
            <a:lvl1pPr marL="0" indent="0">
              <a:buNone/>
              <a:defRPr sz="7559"/>
            </a:lvl1pPr>
            <a:lvl2pPr marL="1080044" indent="0">
              <a:buNone/>
              <a:defRPr sz="6614"/>
            </a:lvl2pPr>
            <a:lvl3pPr marL="2160087" indent="0">
              <a:buNone/>
              <a:defRPr sz="5670"/>
            </a:lvl3pPr>
            <a:lvl4pPr marL="3240131" indent="0">
              <a:buNone/>
              <a:defRPr sz="4725"/>
            </a:lvl4pPr>
            <a:lvl5pPr marL="4320174" indent="0">
              <a:buNone/>
              <a:defRPr sz="4725"/>
            </a:lvl5pPr>
            <a:lvl6pPr marL="5400218" indent="0">
              <a:buNone/>
              <a:defRPr sz="4725"/>
            </a:lvl6pPr>
            <a:lvl7pPr marL="6480261" indent="0">
              <a:buNone/>
              <a:defRPr sz="4725"/>
            </a:lvl7pPr>
            <a:lvl8pPr marL="7560305" indent="0">
              <a:buNone/>
              <a:defRPr sz="4725"/>
            </a:lvl8pPr>
            <a:lvl9pPr marL="8640348" indent="0">
              <a:buNone/>
              <a:defRPr sz="47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0" y="7019925"/>
            <a:ext cx="6966921" cy="13005279"/>
          </a:xfrm>
        </p:spPr>
        <p:txBody>
          <a:bodyPr/>
          <a:lstStyle>
            <a:lvl1pPr marL="0" indent="0">
              <a:buNone/>
              <a:defRPr sz="3780"/>
            </a:lvl1pPr>
            <a:lvl2pPr marL="1080044" indent="0">
              <a:buNone/>
              <a:defRPr sz="3307"/>
            </a:lvl2pPr>
            <a:lvl3pPr marL="2160087" indent="0">
              <a:buNone/>
              <a:defRPr sz="2835"/>
            </a:lvl3pPr>
            <a:lvl4pPr marL="3240131" indent="0">
              <a:buNone/>
              <a:defRPr sz="2362"/>
            </a:lvl4pPr>
            <a:lvl5pPr marL="4320174" indent="0">
              <a:buNone/>
              <a:defRPr sz="2362"/>
            </a:lvl5pPr>
            <a:lvl6pPr marL="5400218" indent="0">
              <a:buNone/>
              <a:defRPr sz="2362"/>
            </a:lvl6pPr>
            <a:lvl7pPr marL="6480261" indent="0">
              <a:buNone/>
              <a:defRPr sz="2362"/>
            </a:lvl7pPr>
            <a:lvl8pPr marL="7560305" indent="0">
              <a:buNone/>
              <a:defRPr sz="2362"/>
            </a:lvl8pPr>
            <a:lvl9pPr marL="8640348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282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5077" y="1245825"/>
            <a:ext cx="18630960" cy="4522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5077" y="6229100"/>
            <a:ext cx="18630960" cy="148469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5077" y="21688107"/>
            <a:ext cx="4860250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572DC-969F-4476-92FE-D5E98D37F2CE}" type="datetimeFigureOut">
              <a:rPr lang="zh-CN" altLang="en-US" smtClean="0"/>
              <a:t>2024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5369" y="21688107"/>
            <a:ext cx="7290376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5786" y="21688107"/>
            <a:ext cx="4860250" cy="12458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73BCD-5DD9-4D23-961A-F2003C55DB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3381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160087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0022" indent="-540022" algn="l" defTabSz="2160087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20065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2pPr>
      <a:lvl3pPr marL="2700109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3pPr>
      <a:lvl4pPr marL="3780152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60196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40240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20283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100327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80370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80044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60087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40131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20174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400218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80261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60305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40348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C3E5EA6-33E3-8621-AF33-1F3E9018FE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9185" b="22554"/>
          <a:stretch/>
        </p:blipFill>
        <p:spPr>
          <a:xfrm>
            <a:off x="3886767" y="2169432"/>
            <a:ext cx="10123147" cy="20213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2416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9E657B1-FF89-0B5E-FB50-284F98243228}"/>
              </a:ext>
            </a:extLst>
          </p:cNvPr>
          <p:cNvSpPr txBox="1"/>
          <p:nvPr/>
        </p:nvSpPr>
        <p:spPr>
          <a:xfrm>
            <a:off x="2024744" y="4846293"/>
            <a:ext cx="19169742" cy="452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. Phylogenetic analysis based on whole genome sequences of dasheen mosaic virus. Phylogenetic tree generated using the Maximum Likelihood method and Tamura-</a:t>
            </a:r>
            <a:r>
              <a:rPr lang="en-US" altLang="zh-CN" sz="4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ei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model with 1,000 bootstrap replications in MEGA11. The tree was rooted using Konjac mosaic virus (</a:t>
            </a:r>
            <a:r>
              <a:rPr lang="en-US" altLang="zh-CN" sz="4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KoMV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, genus </a:t>
            </a:r>
            <a:r>
              <a:rPr lang="en-US" altLang="zh-CN" sz="4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otyvirus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family </a:t>
            </a:r>
            <a:r>
              <a:rPr lang="en-US" altLang="zh-CN" sz="4800" i="1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otyviridae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s an outgroup. Bootstrap values greater than 50% are shown.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2133755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E6F0CAF9-64E5-EB29-F35F-95C37FC062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21796"/>
            <a:ext cx="20993697" cy="1058460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C440F44-411E-221D-A645-CE9F1DE67098}"/>
              </a:ext>
            </a:extLst>
          </p:cNvPr>
          <p:cNvSpPr txBox="1"/>
          <p:nvPr/>
        </p:nvSpPr>
        <p:spPr>
          <a:xfrm>
            <a:off x="5100256" y="16805506"/>
            <a:ext cx="14396058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3. Pairwise alignment of N terminal aa sequences of the CP gene of </a:t>
            </a:r>
            <a:r>
              <a:rPr lang="en-US" altLang="zh-CN" sz="4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sMV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isolates identified in this study and other 22 </a:t>
            </a:r>
            <a:r>
              <a:rPr lang="en-US" altLang="zh-CN" sz="48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DsMV</a:t>
            </a:r>
            <a:r>
              <a:rPr lang="en-US" altLang="zh-CN" sz="4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isolates in GenBank.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3995862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521</TotalTime>
  <Words>91</Words>
  <Application>Microsoft Office PowerPoint</Application>
  <PresentationFormat>自定义</PresentationFormat>
  <Paragraphs>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1 Typical disease symptoms of amorphorallus leaves</dc:title>
  <dc:creator>jh dong</dc:creator>
  <cp:lastModifiedBy>jh dong</cp:lastModifiedBy>
  <cp:revision>68</cp:revision>
  <dcterms:created xsi:type="dcterms:W3CDTF">2023-07-10T01:12:52Z</dcterms:created>
  <dcterms:modified xsi:type="dcterms:W3CDTF">2024-05-10T07:45:44Z</dcterms:modified>
</cp:coreProperties>
</file>